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E34225-5625-41B1-9EB1-44C683A1B79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6EBA5C-205A-4E50-975E-9F8050BCCEC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DBA777-1DCC-4DD4-B0FE-698613CF8C5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4D6AFA-F9DD-453A-9240-3EA52A2EC19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053204-D572-4967-AAC9-948B272D7F1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AAC043-9F70-4749-9C45-45CE8208209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47CB42-9844-4BB2-B2DD-E9C7FDEC5CF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E6A49A-02B1-47E4-B5EE-CEF906EEB3C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F479B8-5870-4C57-942B-D7382601FEE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A6AB41-B3BA-4A58-A952-1571F45577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88B649-B959-4BD3-AB57-D91143D82C9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13F28A-82EA-40D1-B8F9-1207F0CFBEE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4F6E1EB-5EE3-438E-94A2-5F68F0589180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000080" y="1357200"/>
          <a:ext cx="7215120" cy="2735280"/>
        </p:xfrm>
        <a:graphic>
          <a:graphicData uri="http://schemas.openxmlformats.org/drawingml/2006/table">
            <a:tbl>
              <a:tblPr/>
              <a:tblGrid>
                <a:gridCol w="635040"/>
                <a:gridCol w="1552680"/>
                <a:gridCol w="846000"/>
                <a:gridCol w="3195720"/>
                <a:gridCol w="985680"/>
              </a:tblGrid>
              <a:tr h="203400">
                <a:tc gridSpan="5"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14200"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600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trai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esistanc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rigi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es. Mechanis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ovid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3040">
                <a:tc>
                  <a:txBody>
                    <a:bodyPr lIns="7920" rIns="7920" tIns="79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F5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n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atient N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n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och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7160">
                <a:tc>
                  <a:txBody>
                    <a:bodyPr lIns="7920" rIns="7920" tIns="79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l-PL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Q, PYR, CYC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hailan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fmdr1, pfcrt, pfdhfr, pfdhps gene mutation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R4 (MRA-159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4840">
                <a:tc>
                  <a:txBody>
                    <a:bodyPr lIns="7920" rIns="7920" tIns="79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V1/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l-PL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Q, PYR, CYC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Vietna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fmdr1, pfcrt, pfdhfr, pfdhps gene mutation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R4 (MRA-176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5640">
                <a:tc>
                  <a:txBody>
                    <a:bodyPr lIns="7920" rIns="7920" tIns="79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G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l-PL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Q, PYR, CYC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razi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fmdr1,,pfcrt, pfdhfr, pfdhps gene mutation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R4 (MRA-152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7160">
                <a:tc>
                  <a:txBody>
                    <a:bodyPr lIns="7920" rIns="7920" tIns="79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Q, PYR, QUI, CYC, SUL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ndochin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fmdr1, pfcrt, pfdhfr, pfdhps gene mutation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R4 (MRA-157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809640">
                <a:tc>
                  <a:txBody>
                    <a:bodyPr lIns="7920" rIns="7920" tIns="79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M90C2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Q, PYR, MFQ, CY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hailan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ollected from high grade resistance failure of mefloquine plus tetracycline; known genotypes (pfcrt, pfmdr1, dhfr, dhps &amp; cytB); pfmdr1 copy number may oscillate between 1-3 during long term culture (pfcrt, pfmdr1, dhfr, dhps &amp; cytB)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R4 (MRA-202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4200">
                <a:tc>
                  <a:txBody>
                    <a:bodyPr lIns="7920" rIns="7920" tIns="79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FQ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ierra Leon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fcrt, pfmdr1, dhfr, dhp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R4 (MRA-285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2-22T21:38:59Z</dcterms:created>
  <dc:creator>didier</dc:creator>
  <dc:description/>
  <dc:language>en-US</dc:language>
  <cp:lastModifiedBy>Didier Leroy</cp:lastModifiedBy>
  <dcterms:modified xsi:type="dcterms:W3CDTF">2012-01-16T16:23:02Z</dcterms:modified>
  <cp:revision>8</cp:revision>
  <dc:subject/>
  <dc:title>Slide 1</dc:title>
</cp:coreProperties>
</file>